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92" d="100"/>
          <a:sy n="92" d="100"/>
        </p:scale>
        <p:origin x="2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486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9854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673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78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7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2388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93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6799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7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95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6568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BA824-C238-48EB-9B5D-4BFE05F4E125}" type="datetimeFigureOut">
              <a:rPr lang="zh-CN" altLang="en-US" smtClean="0"/>
              <a:t>2016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FC10DB-EBA8-472E-9910-417728DDA8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8405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3"/>
          <p:cNvSpPr>
            <a:spLocks noGrp="1" noChangeArrowheads="1"/>
          </p:cNvSpPr>
          <p:nvPr>
            <p:ph type="ctrTitle"/>
          </p:nvPr>
        </p:nvSpPr>
        <p:spPr bwMode="auto">
          <a:xfrm>
            <a:off x="1892300" y="-102837"/>
            <a:ext cx="8724900" cy="4154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066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0668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materials</a:t>
            </a:r>
            <a:b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1. The FCs among the left MFG, left IPS, and VWFA during task-driven fMRI (EXP1)</a:t>
            </a:r>
            <a:r>
              <a:rPr kumimoji="0" lang="en-US" altLang="zh-CN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s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fMRI (EXP2) with global signals remained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10668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kumimoji="0" lang="en-US" altLang="zh-CN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kumimoji="0" lang="en-US" altLang="zh-CN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kumimoji="0" lang="en-US" altLang="zh-CN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kumimoji="0" lang="en-US" altLang="zh-CN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892300" y="1916603"/>
            <a:ext cx="6096000" cy="55399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ificant correlations are at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.001 (***).</a:t>
            </a:r>
            <a:endParaRPr lang="zh-CN" altLang="en-US" sz="1600" dirty="0"/>
          </a:p>
        </p:txBody>
      </p:sp>
      <p:graphicFrame>
        <p:nvGraphicFramePr>
          <p:cNvPr id="20" name="表格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6232879"/>
              </p:ext>
            </p:extLst>
          </p:nvPr>
        </p:nvGraphicFramePr>
        <p:xfrm>
          <a:off x="2003511" y="1158861"/>
          <a:ext cx="5626099" cy="975360"/>
        </p:xfrm>
        <a:graphic>
          <a:graphicData uri="http://schemas.openxmlformats.org/drawingml/2006/table">
            <a:tbl>
              <a:tblPr/>
              <a:tblGrid>
                <a:gridCol w="1187683"/>
                <a:gridCol w="1674853"/>
                <a:gridCol w="1278959"/>
                <a:gridCol w="1484604"/>
              </a:tblGrid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C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IPS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PS-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XP1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88***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0***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49***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XP2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23***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84***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573***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3"/>
          <p:cNvSpPr txBox="1">
            <a:spLocks noChangeArrowheads="1"/>
          </p:cNvSpPr>
          <p:nvPr/>
        </p:nvSpPr>
        <p:spPr bwMode="auto">
          <a:xfrm>
            <a:off x="1892300" y="1513701"/>
            <a:ext cx="8674100" cy="4289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ctr" anchorCtr="0" compatLnSpc="1">
            <a:prstTxWarp prst="textNoShape">
              <a:avLst/>
            </a:prstTxWarp>
            <a:spAutoFit/>
          </a:bodyPr>
          <a:lstStyle>
            <a:lvl1pPr indent="1066800" algn="ctr" defTabSz="914400" rtl="0" eaLnBrk="0" fontAlgn="base" latinLnBrk="0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None/>
              <a:defRPr sz="6000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+mj-cs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l">
              <a:lnSpc>
                <a:spcPct val="100000"/>
              </a:lnSpc>
            </a:pP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The ECs among the left MFG, left IPS, and VWFA during task-driven fMRI (EXP1) and </a:t>
            </a:r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fMRI (EXP2) with global signals remained.</a:t>
            </a: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en-US" altLang="zh-CN" sz="2400" dirty="0" smtClean="0"/>
          </a:p>
        </p:txBody>
      </p:sp>
      <p:sp>
        <p:nvSpPr>
          <p:cNvPr id="6" name="矩形 5"/>
          <p:cNvSpPr/>
          <p:nvPr/>
        </p:nvSpPr>
        <p:spPr>
          <a:xfrm>
            <a:off x="1892300" y="4189186"/>
            <a:ext cx="6858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600" i="1" kern="100" dirty="0">
                <a:latin typeface="Times New Roman" panose="02020603050405020304" pitchFamily="18" charset="0"/>
              </a:rPr>
              <a:t>Note: 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Significant correlations are at</a:t>
            </a:r>
            <a:r>
              <a:rPr lang="en-US" altLang="zh-CN" sz="1600" i="1" kern="100" dirty="0">
                <a:latin typeface="Times New Roman" panose="02020603050405020304" pitchFamily="18" charset="0"/>
              </a:rPr>
              <a:t> </a:t>
            </a:r>
            <a:r>
              <a:rPr lang="en-US" altLang="zh-CN" sz="1600" i="1" kern="100" dirty="0" smtClean="0">
                <a:latin typeface="Times New Roman" panose="02020603050405020304" pitchFamily="18" charset="0"/>
              </a:rPr>
              <a:t>p</a:t>
            </a:r>
            <a:r>
              <a:rPr lang="en-US" altLang="zh-CN" sz="1600" kern="100" dirty="0" smtClean="0">
                <a:latin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&lt; .01 (**), and </a:t>
            </a:r>
            <a:r>
              <a:rPr lang="en-US" altLang="zh-CN" sz="1600" i="1" kern="100" dirty="0">
                <a:latin typeface="Times New Roman" panose="02020603050405020304" pitchFamily="18" charset="0"/>
              </a:rPr>
              <a:t>p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 &lt; .001 (***).</a:t>
            </a:r>
            <a:endParaRPr lang="zh-CN" altLang="zh-CN" sz="1200" kern="100" dirty="0">
              <a:latin typeface="Times New Roman" panose="02020603050405020304" pitchFamily="18" charset="0"/>
            </a:endParaRPr>
          </a:p>
        </p:txBody>
      </p:sp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488238"/>
              </p:ext>
            </p:extLst>
          </p:nvPr>
        </p:nvGraphicFramePr>
        <p:xfrm>
          <a:off x="1962150" y="3083234"/>
          <a:ext cx="8585200" cy="1057910"/>
        </p:xfrm>
        <a:graphic>
          <a:graphicData uri="http://schemas.openxmlformats.org/drawingml/2006/table">
            <a:tbl>
              <a:tblPr/>
              <a:tblGrid>
                <a:gridCol w="888293"/>
                <a:gridCol w="1364519"/>
                <a:gridCol w="1364519"/>
                <a:gridCol w="1262530"/>
                <a:gridCol w="1068420"/>
                <a:gridCol w="1415514"/>
                <a:gridCol w="1221405"/>
              </a:tblGrid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C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09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&gt;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VWFA-&gt;MFG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&gt;IPS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PS-&gt;MFG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PS-&gt;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VWFA-&gt;IPS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XP1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114***</a:t>
                      </a:r>
                      <a:endParaRPr lang="zh-CN" sz="1600" ker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0.032</a:t>
                      </a:r>
                      <a:endParaRPr lang="zh-CN" sz="1600" ker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125***</a:t>
                      </a:r>
                      <a:endParaRPr lang="zh-CN" sz="1600" ker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0.046</a:t>
                      </a:r>
                      <a:endParaRPr lang="zh-CN" sz="1600" ker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101***</a:t>
                      </a:r>
                      <a:endParaRPr lang="zh-CN" sz="1600" ker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018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639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XP2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012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0.028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058***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0.052**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0.009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+mn-cs"/>
                        </a:rPr>
                        <a:t>-0.015</a:t>
                      </a:r>
                      <a:endParaRPr lang="zh-CN" sz="160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Rectangle 3"/>
          <p:cNvSpPr txBox="1">
            <a:spLocks noChangeArrowheads="1"/>
          </p:cNvSpPr>
          <p:nvPr/>
        </p:nvSpPr>
        <p:spPr bwMode="auto">
          <a:xfrm>
            <a:off x="1892300" y="3635220"/>
            <a:ext cx="8801100" cy="42473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ctr" anchorCtr="0" compatLnSpc="1">
            <a:prstTxWarp prst="textNoShape">
              <a:avLst/>
            </a:prstTxWarp>
            <a:spAutoFit/>
          </a:bodyPr>
          <a:lstStyle>
            <a:lvl1pPr indent="1066800" algn="ctr" defTabSz="914400" rtl="0" eaLnBrk="0" fontAlgn="base" latinLnBrk="0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None/>
              <a:defRPr sz="6000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+mj-cs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l">
              <a:lnSpc>
                <a:spcPct val="100000"/>
              </a:lnSpc>
            </a:pP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20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The correlations between strength of FCs and the reading score (Lexical decision and Reading fluency) with global signals remained.</a:t>
            </a: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en-US" altLang="zh-CN" sz="14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en-US" altLang="zh-CN" sz="2400" dirty="0" smtClean="0"/>
          </a:p>
        </p:txBody>
      </p:sp>
      <p:sp>
        <p:nvSpPr>
          <p:cNvPr id="10" name="矩形 9"/>
          <p:cNvSpPr/>
          <p:nvPr/>
        </p:nvSpPr>
        <p:spPr>
          <a:xfrm>
            <a:off x="1620451" y="6220005"/>
            <a:ext cx="60960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pPr indent="304800" algn="just">
              <a:spcAft>
                <a:spcPts val="0"/>
              </a:spcAft>
            </a:pPr>
            <a:r>
              <a:rPr lang="en-US" altLang="zh-CN" sz="1600" i="1" kern="100" dirty="0">
                <a:latin typeface="Times New Roman" panose="02020603050405020304" pitchFamily="18" charset="0"/>
              </a:rPr>
              <a:t>Note: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 Significant correlations are at </a:t>
            </a:r>
            <a:r>
              <a:rPr lang="en-US" altLang="zh-CN" sz="1600" i="1" kern="100" dirty="0">
                <a:latin typeface="Times New Roman" panose="02020603050405020304" pitchFamily="18" charset="0"/>
              </a:rPr>
              <a:t>p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 &lt; .1 (</a:t>
            </a:r>
            <a:r>
              <a:rPr lang="en-US" altLang="zh-CN" sz="1600" kern="100" baseline="30000" dirty="0">
                <a:latin typeface="Times New Roman" panose="02020603050405020304" pitchFamily="18" charset="0"/>
              </a:rPr>
              <a:t>~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) and </a:t>
            </a:r>
            <a:r>
              <a:rPr lang="en-US" altLang="zh-CN" sz="1600" i="1" kern="100" dirty="0">
                <a:latin typeface="Times New Roman" panose="02020603050405020304" pitchFamily="18" charset="0"/>
              </a:rPr>
              <a:t>p</a:t>
            </a:r>
            <a:r>
              <a:rPr lang="en-US" altLang="zh-CN" sz="1600" kern="100" dirty="0">
                <a:latin typeface="Times New Roman" panose="02020603050405020304" pitchFamily="18" charset="0"/>
              </a:rPr>
              <a:t> &lt; .01 (**).</a:t>
            </a:r>
            <a:endParaRPr lang="zh-CN" altLang="zh-CN" sz="1200" kern="100" dirty="0">
              <a:latin typeface="Times New Roman" panose="02020603050405020304" pitchFamily="18" charset="0"/>
            </a:endParaRPr>
          </a:p>
        </p:txBody>
      </p:sp>
      <p:graphicFrame>
        <p:nvGraphicFramePr>
          <p:cNvPr id="11" name="表格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9384904"/>
              </p:ext>
            </p:extLst>
          </p:nvPr>
        </p:nvGraphicFramePr>
        <p:xfrm>
          <a:off x="2003511" y="5208925"/>
          <a:ext cx="7188200" cy="975360"/>
        </p:xfrm>
        <a:graphic>
          <a:graphicData uri="http://schemas.openxmlformats.org/drawingml/2006/table">
            <a:tbl>
              <a:tblPr/>
              <a:tblGrid>
                <a:gridCol w="1272537"/>
                <a:gridCol w="1737935"/>
                <a:gridCol w="2088864"/>
                <a:gridCol w="2088864"/>
              </a:tblGrid>
              <a:tr h="20002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Lexical decision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eading fluency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C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469**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.231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FG-IPS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.279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0.343</a:t>
                      </a:r>
                      <a:r>
                        <a:rPr lang="en-US" sz="160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~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PS-VWFA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.244</a:t>
                      </a:r>
                      <a:endParaRPr lang="zh-CN" sz="12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.295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71675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8073" y="3147032"/>
            <a:ext cx="4572638" cy="3429479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3525" y="3147033"/>
            <a:ext cx="4572638" cy="342947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8073" y="76929"/>
            <a:ext cx="4572638" cy="342947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93525" y="81300"/>
            <a:ext cx="4572638" cy="3429479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034608" y="1391559"/>
            <a:ext cx="10390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ing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071316" y="4620983"/>
            <a:ext cx="9669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ing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945808" y="3072812"/>
            <a:ext cx="26078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connectivity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990804" y="3072812"/>
            <a:ext cx="24466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ive connectivity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071316" y="5819858"/>
            <a:ext cx="98544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C and FC for reading-driven fMRI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fMRI in the right hemisphere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coefficients are at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5 (*)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1 (**), and </a:t>
            </a:r>
            <a:r>
              <a:rPr lang="en-US" altLang="zh-CN" i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1 (***),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solid line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034608" y="0"/>
            <a:ext cx="26789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94865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545540C5CC05F49B9F102AC9006ABC0" ma:contentTypeVersion="7" ma:contentTypeDescription="Create a new document." ma:contentTypeScope="" ma:versionID="13dd8d8b02aecb40adc89552bf514269">
  <xsd:schema xmlns:xsd="http://www.w3.org/2001/XMLSchema" xmlns:p="http://schemas.microsoft.com/office/2006/metadata/properties" xmlns:ns2="ad6050de-b204-4cd9-b492-5bc34f5a8a79" targetNamespace="http://schemas.microsoft.com/office/2006/metadata/properties" ma:root="true" ma:fieldsID="ba31fb450d54352de63754597d7a3f68" ns2:_="">
    <xsd:import namespace="ad6050de-b204-4cd9-b492-5bc34f5a8a79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6050de-b204-4cd9-b492-5bc34f5a8a79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ad6050de-b204-4cd9-b492-5bc34f5a8a79">PPTX</FileFormat>
    <DocumentId xmlns="ad6050de-b204-4cd9-b492-5bc34f5a8a79">Presentation 1.PPTX</DocumentId>
    <IsDeleted xmlns="ad6050de-b204-4cd9-b492-5bc34f5a8a79">false</IsDeleted>
    <Checked_x0020_Out_x0020_To xmlns="ad6050de-b204-4cd9-b492-5bc34f5a8a79">
      <UserInfo>
        <DisplayName/>
        <AccountId xsi:nil="true"/>
        <AccountType/>
      </UserInfo>
    </Checked_x0020_Out_x0020_To>
    <DocumentType xmlns="ad6050de-b204-4cd9-b492-5bc34f5a8a79">Presentation</DocumentType>
    <TitleName xmlns="ad6050de-b204-4cd9-b492-5bc34f5a8a79">Presentation 1.PPTX</TitleName>
    <StageName xmlns="ad6050de-b204-4cd9-b492-5bc34f5a8a79" xsi:nil="true"/>
  </documentManagement>
</p:properties>
</file>

<file path=customXml/itemProps1.xml><?xml version="1.0" encoding="utf-8"?>
<ds:datastoreItem xmlns:ds="http://schemas.openxmlformats.org/officeDocument/2006/customXml" ds:itemID="{69C76807-E109-49FE-9011-C4F505D5DDA5}"/>
</file>

<file path=customXml/itemProps2.xml><?xml version="1.0" encoding="utf-8"?>
<ds:datastoreItem xmlns:ds="http://schemas.openxmlformats.org/officeDocument/2006/customXml" ds:itemID="{F6E308CB-BDC0-4699-86D3-F3089AE38F86}"/>
</file>

<file path=customXml/itemProps3.xml><?xml version="1.0" encoding="utf-8"?>
<ds:datastoreItem xmlns:ds="http://schemas.openxmlformats.org/officeDocument/2006/customXml" ds:itemID="{64586BA1-7590-4708-B6AC-CB62FBF7308B}"/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123</Words>
  <Application>Microsoft Office PowerPoint</Application>
  <PresentationFormat>宽屏</PresentationFormat>
  <Paragraphs>6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 Supplementary materials Table S1. The FCs among the left MFG, left IPS, and VWFA during task-driven fMRI (EXP1) and rs-fMRI (EXP2) with global signals remained.             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  Table S1. The FCs among the left MFG, left IPS, and VWFA during task-driven fMRI (EXP1)  and rs-fMRI (EXP2) with global signals remained.</dc:title>
  <dc:creator>bnuzw</dc:creator>
  <cp:lastModifiedBy>bnuzw</cp:lastModifiedBy>
  <cp:revision>14</cp:revision>
  <dcterms:created xsi:type="dcterms:W3CDTF">2016-05-31T14:14:51Z</dcterms:created>
  <dcterms:modified xsi:type="dcterms:W3CDTF">2016-08-07T09:32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545540C5CC05F49B9F102AC9006ABC0</vt:lpwstr>
  </property>
</Properties>
</file>